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84"/>
  </p:normalViewPr>
  <p:slideViewPr>
    <p:cSldViewPr snapToGrid="0" snapToObjects="1">
      <p:cViewPr varScale="1">
        <p:scale>
          <a:sx n="106" d="100"/>
          <a:sy n="106" d="100"/>
        </p:scale>
        <p:origin x="75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E4B8B2B-1D8A-1043-91EC-0CB285E2C7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95B898CD-02EA-7F43-BDF2-9FD1DAFF45E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ES_tradn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A70EAEB-AAAD-C642-8028-EEB9D7985B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B71E-FA0B-E244-BCE0-EE9A2278D060}" type="datetimeFigureOut">
              <a:rPr lang="es-ES_tradnl" smtClean="0"/>
              <a:t>23/02/2022</a:t>
            </a:fld>
            <a:endParaRPr lang="es-ES_tradn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58AB505-15E3-D44B-AC49-8F152B02A8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9DCB97F-09C5-A74C-B4FA-A8E7261466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62B61-99EE-F548-963C-87D8F96E4D5A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1987913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9E228DB-168A-C24C-AD8B-443A1A0C21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8749DA86-F84D-624D-B421-903056E077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es-ES"/>
              <a:t>Editar los estilos de texto del patrón
Segundo nivel
Tercer nivel
Cuarto nivel
Quinto nivel</a:t>
            </a:r>
            <a:endParaRPr lang="es-ES_tradn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997A7BD-594B-474C-AD64-EBCD16CE56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B71E-FA0B-E244-BCE0-EE9A2278D060}" type="datetimeFigureOut">
              <a:rPr lang="es-ES_tradnl" smtClean="0"/>
              <a:t>23/02/2022</a:t>
            </a:fld>
            <a:endParaRPr lang="es-ES_tradn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F03CCB4-A2F4-0848-B012-432782E751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CDB1B73-5224-C549-86FB-8EC7767F1E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62B61-99EE-F548-963C-87D8F96E4D5A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4624494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74B8A938-6A0E-FA44-BF65-7ABCABF0E05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AF4A04FC-3298-494F-92B7-E12D7D1D6E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es-ES"/>
              <a:t>Editar los estilos de texto del patrón
Segundo nivel
Tercer nivel
Cuarto nivel
Quinto nivel</a:t>
            </a:r>
            <a:endParaRPr lang="es-ES_tradn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093F0F5-D86B-404A-87D6-7EB7BD604B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B71E-FA0B-E244-BCE0-EE9A2278D060}" type="datetimeFigureOut">
              <a:rPr lang="es-ES_tradnl" smtClean="0"/>
              <a:t>23/02/2022</a:t>
            </a:fld>
            <a:endParaRPr lang="es-ES_tradn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321D464-A86B-8840-8D32-4BF1D2D27D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9B0E562-4919-AD45-BFE1-E3CB2E5095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62B61-99EE-F548-963C-87D8F96E4D5A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2649198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AD5DFCE-442C-7B42-8D38-3AB0E23CE0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2A1499F3-354E-EE44-97EF-F067B563CFE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s-ES"/>
              <a:t>Editar los estilos de texto del patrón
Segundo nivel
Tercer nivel
Cuarto nivel
Quinto nivel</a:t>
            </a:r>
            <a:endParaRPr lang="es-ES_tradn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D31F676-B42E-AB4A-9D26-4FA6BF9BE8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B71E-FA0B-E244-BCE0-EE9A2278D060}" type="datetimeFigureOut">
              <a:rPr lang="es-ES_tradnl" smtClean="0"/>
              <a:t>23/02/2022</a:t>
            </a:fld>
            <a:endParaRPr lang="es-ES_tradn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6BFFECC-BC80-4F4F-82F7-7D0939063A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64E7A7D-8D26-6640-8AD0-E9BA55EC03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62B61-99EE-F548-963C-87D8F96E4D5A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844525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931A77F-77E3-EE4D-89C4-D1B7EA369C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A7AA8CFD-728D-FC45-B448-61D03D6B95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Editar los estilos de texto del patrón
Segundo nivel
Tercer nivel
Cuarto nivel
Quinto nivel</a:t>
            </a:r>
            <a:endParaRPr lang="es-ES_tradn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EB60F58-4912-1740-B4C9-72203B1E10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B71E-FA0B-E244-BCE0-EE9A2278D060}" type="datetimeFigureOut">
              <a:rPr lang="es-ES_tradnl" smtClean="0"/>
              <a:t>23/02/2022</a:t>
            </a:fld>
            <a:endParaRPr lang="es-ES_tradn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3CB2998-8890-3144-AD1D-69EAE6E67F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B04E30A-BFA3-E64C-9B8A-F1BBDAAFFA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62B61-99EE-F548-963C-87D8F96E4D5A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42155410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6E17AF7-B398-A947-BAC7-AAD1D9F90E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F8EBEF3E-3C5B-6A48-BA48-2813400B6AC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es-ES"/>
              <a:t>Editar los estilos de texto del patrón
Segundo nivel
Tercer nivel
Cuarto nivel
Quinto nivel</a:t>
            </a:r>
            <a:endParaRPr lang="es-ES_tradnl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43E7E13D-BA45-3B49-8950-CA1C4806DA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es-ES"/>
              <a:t>Editar los estilos de texto del patrón
Segundo nivel
Tercer nivel
Cuarto nivel
Quinto nivel</a:t>
            </a:r>
            <a:endParaRPr lang="es-ES_tradnl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5C277883-5E8C-0A46-B1C2-18932E52C5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B71E-FA0B-E244-BCE0-EE9A2278D060}" type="datetimeFigureOut">
              <a:rPr lang="es-ES_tradnl" smtClean="0"/>
              <a:t>23/02/2022</a:t>
            </a:fld>
            <a:endParaRPr lang="es-ES_tradn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DA766747-DF06-CA43-82A6-61F913D705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9F8E8231-0AF5-EF40-A980-9F52E15506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62B61-99EE-F548-963C-87D8F96E4D5A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5931342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AA57BA7-7065-5C45-B6B7-928175D209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7F117710-244D-3247-8DD5-BEC1D0ED7B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es-ES"/>
              <a:t>Editar los estilos de texto del patrón
Segundo nivel
Tercer nivel
Cuarto nivel
Quinto nivel</a:t>
            </a:r>
            <a:endParaRPr lang="es-ES_tradnl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D41BE850-204A-634E-8ABD-76EF3CCE01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es-ES"/>
              <a:t>Editar los estilos de texto del patrón
Segundo nivel
Tercer nivel
Cuarto nivel
Quinto nivel</a:t>
            </a:r>
            <a:endParaRPr lang="es-ES_tradnl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B8F046D7-C0C1-D14A-9FBB-AB9A40305CE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es-ES"/>
              <a:t>Editar los estilos de texto del patrón
Segundo nivel
Tercer nivel
Cuarto nivel
Quinto nivel</a:t>
            </a:r>
            <a:endParaRPr lang="es-ES_tradnl"/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011BD9F2-6FC4-2E44-9447-EE3BC28E651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es-ES"/>
              <a:t>Editar los estilos de texto del patrón
Segundo nivel
Tercer nivel
Cuarto nivel
Quinto nivel</a:t>
            </a:r>
            <a:endParaRPr lang="es-ES_tradnl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64758D46-4428-B34E-AFBF-C8D316A623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B71E-FA0B-E244-BCE0-EE9A2278D060}" type="datetimeFigureOut">
              <a:rPr lang="es-ES_tradnl" smtClean="0"/>
              <a:t>23/02/2022</a:t>
            </a:fld>
            <a:endParaRPr lang="es-ES_tradnl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147AF44E-BCF6-324F-9B46-03436D2241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9F5725FC-ACA1-8648-A343-0F49815D68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62B61-99EE-F548-963C-87D8F96E4D5A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6293314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29639BD-048B-2D4A-B763-8CE6574692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B4741BB3-ECA9-8644-AB3F-B588016E01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B71E-FA0B-E244-BCE0-EE9A2278D060}" type="datetimeFigureOut">
              <a:rPr lang="es-ES_tradnl" smtClean="0"/>
              <a:t>23/02/2022</a:t>
            </a:fld>
            <a:endParaRPr lang="es-ES_tradnl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0DD0E171-9D7F-B44C-83BD-543EF8A3AA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2B488C68-5497-9F4C-B5EE-9B22158085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62B61-99EE-F548-963C-87D8F96E4D5A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454042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20C259C0-A7B8-9842-9CA1-A6BC51E929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B71E-FA0B-E244-BCE0-EE9A2278D060}" type="datetimeFigureOut">
              <a:rPr lang="es-ES_tradnl" smtClean="0"/>
              <a:t>23/02/2022</a:t>
            </a:fld>
            <a:endParaRPr lang="es-ES_tradnl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9333B34F-D99B-9347-BD50-2D8D5E4105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874A533B-7911-D245-A43F-0F26ACB616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62B61-99EE-F548-963C-87D8F96E4D5A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0351140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BB87E8E-E0B7-3E41-B83F-BB9FBDECEC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B5E37347-F164-4148-A2D6-5B3CA2859BD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es-ES"/>
              <a:t>Editar los estilos de texto del patrón
Segundo nivel
Tercer nivel
Cuarto nivel
Quinto nivel</a:t>
            </a:r>
            <a:endParaRPr lang="es-ES_tradn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6C7EB56B-EBB3-2C4D-9D9E-E2AE157765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es-ES"/>
              <a:t>Editar los estilos de texto del patrón
Segundo nivel
Tercer nivel
Cuarto nivel
Quinto nivel</a:t>
            </a:r>
            <a:endParaRPr lang="es-ES_tradnl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826EFCE7-7D6C-E34F-ACE4-7C3D4B50BB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B71E-FA0B-E244-BCE0-EE9A2278D060}" type="datetimeFigureOut">
              <a:rPr lang="es-ES_tradnl" smtClean="0"/>
              <a:t>23/02/2022</a:t>
            </a:fld>
            <a:endParaRPr lang="es-ES_tradn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39E4DF68-B1E8-2743-AB1B-43DAF70465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675F86BD-5A0F-B444-8BCE-FE112F4004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62B61-99EE-F548-963C-87D8F96E4D5A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5251510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407543C-02C7-B349-AB66-D10EEE1BCC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A9971A89-8E77-834F-BA4D-813B0CD466E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_tradn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576ADAA5-7BAF-C342-810E-CDA01728DF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es-ES"/>
              <a:t>Editar los estilos de texto del patrón
Segundo nivel
Tercer nivel
Cuarto nivel
Quinto nivel</a:t>
            </a:r>
            <a:endParaRPr lang="es-ES_tradnl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544310DE-A32E-564B-BBD9-4D6B07E562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3CB71E-FA0B-E244-BCE0-EE9A2278D060}" type="datetimeFigureOut">
              <a:rPr lang="es-ES_tradnl" smtClean="0"/>
              <a:t>23/02/2022</a:t>
            </a:fld>
            <a:endParaRPr lang="es-ES_tradn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45C14EC4-43E0-244B-8135-FFE1C70DAA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404F72A-3619-4C47-8939-C0DCC660CA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62B61-99EE-F548-963C-87D8F96E4D5A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6667383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7478219E-2AF1-C94A-A3AA-7EAC481954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B54505A2-59FF-7F4A-856C-76921D13E7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es-ES"/>
              <a:t>Editar los estilos de texto del patrón
Segundo nivel
Tercer nivel
Cuarto nivel
Quinto nivel</a:t>
            </a:r>
            <a:endParaRPr lang="es-ES_tradn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15F0AD7-6FAA-684B-9301-8A452A7F00B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3CB71E-FA0B-E244-BCE0-EE9A2278D060}" type="datetimeFigureOut">
              <a:rPr lang="es-ES_tradnl" smtClean="0"/>
              <a:t>23/02/2022</a:t>
            </a:fld>
            <a:endParaRPr lang="es-ES_tradn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B54845E-09B9-8344-A89D-F13DCEF444A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_tradn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6B7CBFF-05A3-7E45-8B64-06F2CCAFAE9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D62B61-99EE-F548-963C-87D8F96E4D5A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8646293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uadroTexto 6">
            <a:extLst>
              <a:ext uri="{FF2B5EF4-FFF2-40B4-BE49-F238E27FC236}">
                <a16:creationId xmlns:a16="http://schemas.microsoft.com/office/drawing/2014/main" id="{DCC148AE-997C-4443-9DA7-0E5836B583CF}"/>
              </a:ext>
            </a:extLst>
          </p:cNvPr>
          <p:cNvSpPr txBox="1"/>
          <p:nvPr/>
        </p:nvSpPr>
        <p:spPr>
          <a:xfrm>
            <a:off x="219532" y="4280739"/>
            <a:ext cx="10069702" cy="24606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S1.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mune cell population and platelets in critically ill, septic and septic shock patients; (</a:t>
            </a: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Leukocyte population detected in critically ill, septic and septic shock patients; (</a:t>
            </a: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Polymorphonuclear cells detected in critically ill, septic and septic shock patients. (</a:t>
            </a: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Platelet population detected in critically ill, septic and septic shock patients. Data obtained from critically ill non-septic patients (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= 5), septic (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= 10) and septic shock (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= 15) patients. Data are expressed as mean ± SD). ns = non-significant. 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value; * 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&lt; 0.05; ** 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&lt; 0.01, *** 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&lt; 0.001. The lines at the top of the box plots indicate differences between compared conditions.</a:t>
            </a:r>
          </a:p>
        </p:txBody>
      </p:sp>
      <p:pic>
        <p:nvPicPr>
          <p:cNvPr id="11" name="Imagen 14">
            <a:extLst>
              <a:ext uri="{FF2B5EF4-FFF2-40B4-BE49-F238E27FC236}">
                <a16:creationId xmlns:a16="http://schemas.microsoft.com/office/drawing/2014/main" id="{E1E479B5-C5B2-44E0-B9E7-316ED8BC595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38479" y="813215"/>
            <a:ext cx="6645910" cy="31673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5877617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14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esús Beltrán García</dc:creator>
  <cp:lastModifiedBy>MDPI</cp:lastModifiedBy>
  <cp:revision>4</cp:revision>
  <dcterms:created xsi:type="dcterms:W3CDTF">2022-02-08T11:28:38Z</dcterms:created>
  <dcterms:modified xsi:type="dcterms:W3CDTF">2022-02-23T06:39:17Z</dcterms:modified>
</cp:coreProperties>
</file>